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6" r:id="rId2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0" autoAdjust="0"/>
    <p:restoredTop sz="94660"/>
  </p:normalViewPr>
  <p:slideViewPr>
    <p:cSldViewPr snapToGrid="0">
      <p:cViewPr varScale="1">
        <p:scale>
          <a:sx n="173" d="100"/>
          <a:sy n="173" d="100"/>
        </p:scale>
        <p:origin x="192" y="3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1D402-D453-4CAA-A292-CDDFED42C2A0}" type="datetimeFigureOut">
              <a:rPr lang="en-US" smtClean="0"/>
              <a:t>12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9C42-BA08-4608-AEA0-529E99FE6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136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1D402-D453-4CAA-A292-CDDFED42C2A0}" type="datetimeFigureOut">
              <a:rPr lang="en-US" smtClean="0"/>
              <a:t>12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9C42-BA08-4608-AEA0-529E99FE6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9537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1D402-D453-4CAA-A292-CDDFED42C2A0}" type="datetimeFigureOut">
              <a:rPr lang="en-US" smtClean="0"/>
              <a:t>12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9C42-BA08-4608-AEA0-529E99FE6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8102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1D402-D453-4CAA-A292-CDDFED42C2A0}" type="datetimeFigureOut">
              <a:rPr lang="en-US" smtClean="0"/>
              <a:t>12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9C42-BA08-4608-AEA0-529E99FE6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5883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1D402-D453-4CAA-A292-CDDFED42C2A0}" type="datetimeFigureOut">
              <a:rPr lang="en-US" smtClean="0"/>
              <a:t>12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9C42-BA08-4608-AEA0-529E99FE6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73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1D402-D453-4CAA-A292-CDDFED42C2A0}" type="datetimeFigureOut">
              <a:rPr lang="en-US" smtClean="0"/>
              <a:t>12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9C42-BA08-4608-AEA0-529E99FE6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4692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1D402-D453-4CAA-A292-CDDFED42C2A0}" type="datetimeFigureOut">
              <a:rPr lang="en-US" smtClean="0"/>
              <a:t>12/2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9C42-BA08-4608-AEA0-529E99FE6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907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1D402-D453-4CAA-A292-CDDFED42C2A0}" type="datetimeFigureOut">
              <a:rPr lang="en-US" smtClean="0"/>
              <a:t>12/2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9C42-BA08-4608-AEA0-529E99FE6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232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1D402-D453-4CAA-A292-CDDFED42C2A0}" type="datetimeFigureOut">
              <a:rPr lang="en-US" smtClean="0"/>
              <a:t>12/2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9C42-BA08-4608-AEA0-529E99FE6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9003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1D402-D453-4CAA-A292-CDDFED42C2A0}" type="datetimeFigureOut">
              <a:rPr lang="en-US" smtClean="0"/>
              <a:t>12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9C42-BA08-4608-AEA0-529E99FE6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8696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1D402-D453-4CAA-A292-CDDFED42C2A0}" type="datetimeFigureOut">
              <a:rPr lang="en-US" smtClean="0"/>
              <a:t>12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9C42-BA08-4608-AEA0-529E99FE6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7644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1D402-D453-4CAA-A292-CDDFED42C2A0}" type="datetimeFigureOut">
              <a:rPr lang="en-US" smtClean="0"/>
              <a:t>12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479C42-BA08-4608-AEA0-529E99FE6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508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ACA11A94-AD46-45D1-89C0-9BB419CC2E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14506294"/>
              </p:ext>
            </p:extLst>
          </p:nvPr>
        </p:nvGraphicFramePr>
        <p:xfrm>
          <a:off x="2363788" y="242888"/>
          <a:ext cx="4402137" cy="49831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8" name="KGPlot" r:id="rId3" imgW="6159240" imgH="7010280" progId="KGraph_Plot">
                  <p:embed/>
                </p:oleObj>
              </mc:Choice>
              <mc:Fallback>
                <p:oleObj name="KGPlot" r:id="rId3" imgW="6159240" imgH="7010280" progId="KGraph_Plo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ACA11A94-AD46-45D1-89C0-9BB419CC2E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63788" y="242888"/>
                        <a:ext cx="4402137" cy="498316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6C1AC712-BD5A-EB45-96AD-686A29E91522}"/>
              </a:ext>
            </a:extLst>
          </p:cNvPr>
          <p:cNvSpPr txBox="1"/>
          <p:nvPr/>
        </p:nvSpPr>
        <p:spPr>
          <a:xfrm>
            <a:off x="261797" y="5658994"/>
            <a:ext cx="860611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Supplemental Figure 1:  </a:t>
            </a:r>
            <a:r>
              <a:rPr lang="en-US" sz="1400" dirty="0"/>
              <a:t>Western blot analysis of detergent soluble cell layers was carried out using anti-collagen I antibodies. Values were normalized to levels of tubulin.  A trend toward greater levels of collagen I in cell layers from HTN(+)HF fibroblasts was observed. Fibroblasts from P2 or P3 were used for analysis. Referent control (n= 4), HTN (-) </a:t>
            </a:r>
            <a:r>
              <a:rPr lang="en-US" sz="1400" dirty="0" err="1"/>
              <a:t>HFpEF</a:t>
            </a:r>
            <a:r>
              <a:rPr lang="en-US" sz="1400" dirty="0"/>
              <a:t> (n=4), HTN(+) </a:t>
            </a:r>
            <a:r>
              <a:rPr lang="en-US" sz="1400" dirty="0" err="1"/>
              <a:t>HFpEF</a:t>
            </a:r>
            <a:r>
              <a:rPr lang="en-US" sz="1400" dirty="0"/>
              <a:t> (n=6)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78921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8</TotalTime>
  <Words>80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KGPlot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icu, Catalin</dc:creator>
  <cp:lastModifiedBy>Microsoft Office User</cp:lastModifiedBy>
  <cp:revision>54</cp:revision>
  <cp:lastPrinted>2021-12-21T14:44:43Z</cp:lastPrinted>
  <dcterms:created xsi:type="dcterms:W3CDTF">2021-06-03T18:20:11Z</dcterms:created>
  <dcterms:modified xsi:type="dcterms:W3CDTF">2021-12-22T15:31:03Z</dcterms:modified>
</cp:coreProperties>
</file>